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6858000" cy="9906000" type="A4"/>
  <p:notesSz cx="6807200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>
      <p:cViewPr varScale="1">
        <p:scale>
          <a:sx n="60" d="100"/>
          <a:sy n="60" d="100"/>
        </p:scale>
        <p:origin x="2558" y="3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DF3-4A94-B2FD-08459688402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DF3-4A94-B2FD-08459688402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DF3-4A94-B2FD-08459688402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0DF3-4A94-B2FD-08459688402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DF3-4A94-B2FD-084596884024}"/>
              </c:ext>
            </c:extLst>
          </c:dPt>
          <c:errBars>
            <c:errBarType val="plus"/>
            <c:errValType val="cust"/>
            <c:noEndCap val="0"/>
            <c:plus>
              <c:numRef>
                <c:f>'JNK1 western'!$P$3:$P$7</c:f>
                <c:numCache>
                  <c:formatCode>General</c:formatCode>
                  <c:ptCount val="5"/>
                  <c:pt idx="0">
                    <c:v>1.1702211402630667E-2</c:v>
                  </c:pt>
                  <c:pt idx="1">
                    <c:v>0.10263767615835546</c:v>
                  </c:pt>
                  <c:pt idx="2">
                    <c:v>5.3928258982866031E-2</c:v>
                  </c:pt>
                  <c:pt idx="3">
                    <c:v>1.267343439865061E-2</c:v>
                  </c:pt>
                  <c:pt idx="4">
                    <c:v>8.4861386176690416E-3</c:v>
                  </c:pt>
                </c:numCache>
              </c:numRef>
            </c:plus>
            <c:minus>
              <c:numRef>
                <c:f>'JNK1 western'!$P$3:$P$7</c:f>
                <c:numCache>
                  <c:formatCode>General</c:formatCode>
                  <c:ptCount val="5"/>
                  <c:pt idx="0">
                    <c:v>1.1702211402630667E-2</c:v>
                  </c:pt>
                  <c:pt idx="1">
                    <c:v>0.10263767615835546</c:v>
                  </c:pt>
                  <c:pt idx="2">
                    <c:v>5.3928258982866031E-2</c:v>
                  </c:pt>
                  <c:pt idx="3">
                    <c:v>1.267343439865061E-2</c:v>
                  </c:pt>
                  <c:pt idx="4">
                    <c:v>8.486138617669041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JNK1 western'!$N$3:$N$7</c:f>
              <c:numCache>
                <c:formatCode>General</c:formatCode>
                <c:ptCount val="5"/>
                <c:pt idx="0">
                  <c:v>4.3632561008030681E-2</c:v>
                </c:pt>
                <c:pt idx="1">
                  <c:v>1</c:v>
                </c:pt>
                <c:pt idx="2">
                  <c:v>0.22171709228080855</c:v>
                </c:pt>
                <c:pt idx="3">
                  <c:v>0.11523865848491317</c:v>
                </c:pt>
                <c:pt idx="4">
                  <c:v>6.503090693203296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F3-4A94-B2FD-0845968840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76251480"/>
        <c:axId val="476245248"/>
      </c:barChart>
      <c:catAx>
        <c:axId val="4762514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6245248"/>
        <c:crosses val="autoZero"/>
        <c:auto val="1"/>
        <c:lblAlgn val="ctr"/>
        <c:lblOffset val="100"/>
        <c:noMultiLvlLbl val="0"/>
      </c:catAx>
      <c:valAx>
        <c:axId val="476245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6251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EDD-4C51-A432-F20ACB3D1E6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DD-4C51-A432-F20ACB3D1E6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DD-4C51-A432-F20ACB3D1E6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0EDD-4C51-A432-F20ACB3D1E6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DD-4C51-A432-F20ACB3D1E66}"/>
              </c:ext>
            </c:extLst>
          </c:dPt>
          <c:errBars>
            <c:errBarType val="plus"/>
            <c:errValType val="cust"/>
            <c:noEndCap val="0"/>
            <c:plus>
              <c:numRef>
                <c:f>'JNK2,3 western'!$P$3:$P$7</c:f>
                <c:numCache>
                  <c:formatCode>General</c:formatCode>
                  <c:ptCount val="5"/>
                  <c:pt idx="0">
                    <c:v>1.4247904249857096E-2</c:v>
                  </c:pt>
                  <c:pt idx="1">
                    <c:v>6.033173990667464E-2</c:v>
                  </c:pt>
                  <c:pt idx="2">
                    <c:v>6.8952162714533541E-2</c:v>
                  </c:pt>
                  <c:pt idx="3">
                    <c:v>2.2360397031610853E-2</c:v>
                  </c:pt>
                  <c:pt idx="4">
                    <c:v>9.4172843847872625E-3</c:v>
                  </c:pt>
                </c:numCache>
              </c:numRef>
            </c:plus>
            <c:minus>
              <c:numRef>
                <c:f>'JNK2,3 western'!$P$3:$P$7</c:f>
                <c:numCache>
                  <c:formatCode>General</c:formatCode>
                  <c:ptCount val="5"/>
                  <c:pt idx="0">
                    <c:v>1.4247904249857096E-2</c:v>
                  </c:pt>
                  <c:pt idx="1">
                    <c:v>6.033173990667464E-2</c:v>
                  </c:pt>
                  <c:pt idx="2">
                    <c:v>6.8952162714533541E-2</c:v>
                  </c:pt>
                  <c:pt idx="3">
                    <c:v>2.2360397031610853E-2</c:v>
                  </c:pt>
                  <c:pt idx="4">
                    <c:v>9.417284384787262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JNK2,3 western'!$N$3:$N$7</c:f>
              <c:numCache>
                <c:formatCode>General</c:formatCode>
                <c:ptCount val="5"/>
                <c:pt idx="0">
                  <c:v>4.8212851422727201E-2</c:v>
                </c:pt>
                <c:pt idx="1">
                  <c:v>1</c:v>
                </c:pt>
                <c:pt idx="2">
                  <c:v>0.26032590657596832</c:v>
                </c:pt>
                <c:pt idx="3">
                  <c:v>0.14860010167558804</c:v>
                </c:pt>
                <c:pt idx="4">
                  <c:v>7.98410456260394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DD-4C51-A432-F20ACB3D1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76172488"/>
        <c:axId val="476181344"/>
      </c:barChart>
      <c:catAx>
        <c:axId val="476172488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6181344"/>
        <c:crosses val="autoZero"/>
        <c:auto val="1"/>
        <c:lblAlgn val="ctr"/>
        <c:lblOffset val="100"/>
        <c:noMultiLvlLbl val="0"/>
      </c:catAx>
      <c:valAx>
        <c:axId val="476181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6172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061-4C28-8DF9-B5EFD1F7618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061-4C28-8DF9-B5EFD1F7618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061-4C28-8DF9-B5EFD1F7618B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F061-4C28-8DF9-B5EFD1F7618B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061-4C28-8DF9-B5EFD1F7618B}"/>
              </c:ext>
            </c:extLst>
          </c:dPt>
          <c:errBars>
            <c:errBarType val="plus"/>
            <c:errValType val="cust"/>
            <c:noEndCap val="0"/>
            <c:plus>
              <c:numRef>
                <c:f>ERK1western!$P$3:$P$7</c:f>
                <c:numCache>
                  <c:formatCode>General</c:formatCode>
                  <c:ptCount val="5"/>
                  <c:pt idx="0">
                    <c:v>0.1683128021822724</c:v>
                  </c:pt>
                  <c:pt idx="1">
                    <c:v>9.8657506845200915E-2</c:v>
                  </c:pt>
                  <c:pt idx="2">
                    <c:v>0.26739017652977215</c:v>
                  </c:pt>
                  <c:pt idx="3">
                    <c:v>0.18746490659180026</c:v>
                  </c:pt>
                  <c:pt idx="4">
                    <c:v>0.13481187561900754</c:v>
                  </c:pt>
                </c:numCache>
              </c:numRef>
            </c:plus>
            <c:minus>
              <c:numRef>
                <c:f>ERK1western!$P$3:$P$7</c:f>
                <c:numCache>
                  <c:formatCode>General</c:formatCode>
                  <c:ptCount val="5"/>
                  <c:pt idx="0">
                    <c:v>0.1683128021822724</c:v>
                  </c:pt>
                  <c:pt idx="1">
                    <c:v>9.8657506845200915E-2</c:v>
                  </c:pt>
                  <c:pt idx="2">
                    <c:v>0.26739017652977215</c:v>
                  </c:pt>
                  <c:pt idx="3">
                    <c:v>0.18746490659180026</c:v>
                  </c:pt>
                  <c:pt idx="4">
                    <c:v>0.134811875619007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ERK1western!$N$3:$N$7</c:f>
              <c:numCache>
                <c:formatCode>General</c:formatCode>
                <c:ptCount val="5"/>
                <c:pt idx="0">
                  <c:v>0.50089685614655655</c:v>
                </c:pt>
                <c:pt idx="1">
                  <c:v>1</c:v>
                </c:pt>
                <c:pt idx="2">
                  <c:v>0.71450484911266365</c:v>
                </c:pt>
                <c:pt idx="3">
                  <c:v>0.56965411285086842</c:v>
                </c:pt>
                <c:pt idx="4">
                  <c:v>0.43379825642128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61-4C28-8DF9-B5EFD1F761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75989992"/>
        <c:axId val="475995896"/>
      </c:barChart>
      <c:catAx>
        <c:axId val="47598999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5995896"/>
        <c:crosses val="autoZero"/>
        <c:auto val="1"/>
        <c:lblAlgn val="ctr"/>
        <c:lblOffset val="100"/>
        <c:noMultiLvlLbl val="0"/>
      </c:catAx>
      <c:valAx>
        <c:axId val="475995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5989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9FA-4CD2-9C21-8668D5081F9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B9FA-4CD2-9C21-8668D5081F9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9FA-4CD2-9C21-8668D5081F9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B9FA-4CD2-9C21-8668D5081F9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9FA-4CD2-9C21-8668D5081F9E}"/>
              </c:ext>
            </c:extLst>
          </c:dPt>
          <c:errBars>
            <c:errBarType val="plus"/>
            <c:errValType val="cust"/>
            <c:noEndCap val="0"/>
            <c:plus>
              <c:numRef>
                <c:f>p38western!$P$3:$P$7</c:f>
                <c:numCache>
                  <c:formatCode>General</c:formatCode>
                  <c:ptCount val="5"/>
                  <c:pt idx="0">
                    <c:v>4.6259381875639619E-2</c:v>
                  </c:pt>
                  <c:pt idx="1">
                    <c:v>6.854269847356631E-2</c:v>
                  </c:pt>
                  <c:pt idx="2">
                    <c:v>8.1847989803706916E-2</c:v>
                  </c:pt>
                  <c:pt idx="3">
                    <c:v>5.8334455514854472E-2</c:v>
                  </c:pt>
                  <c:pt idx="4">
                    <c:v>0.13574981163427366</c:v>
                  </c:pt>
                </c:numCache>
              </c:numRef>
            </c:plus>
            <c:minus>
              <c:numRef>
                <c:f>p38western!$P$3:$P$7</c:f>
                <c:numCache>
                  <c:formatCode>General</c:formatCode>
                  <c:ptCount val="5"/>
                  <c:pt idx="0">
                    <c:v>4.6259381875639619E-2</c:v>
                  </c:pt>
                  <c:pt idx="1">
                    <c:v>6.854269847356631E-2</c:v>
                  </c:pt>
                  <c:pt idx="2">
                    <c:v>8.1847989803706916E-2</c:v>
                  </c:pt>
                  <c:pt idx="3">
                    <c:v>5.8334455514854472E-2</c:v>
                  </c:pt>
                  <c:pt idx="4">
                    <c:v>0.135749811634273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p38western!$N$3:$N$7</c:f>
              <c:numCache>
                <c:formatCode>General</c:formatCode>
                <c:ptCount val="5"/>
                <c:pt idx="0">
                  <c:v>0.18881591479824639</c:v>
                </c:pt>
                <c:pt idx="1">
                  <c:v>1</c:v>
                </c:pt>
                <c:pt idx="2">
                  <c:v>0.40817232267904863</c:v>
                </c:pt>
                <c:pt idx="3">
                  <c:v>0.38278657103599689</c:v>
                </c:pt>
                <c:pt idx="4">
                  <c:v>0.3373400989202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FA-4CD2-9C21-8668D5081F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67042640"/>
        <c:axId val="467044608"/>
      </c:barChart>
      <c:catAx>
        <c:axId val="4670426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044608"/>
        <c:crosses val="autoZero"/>
        <c:auto val="1"/>
        <c:lblAlgn val="ctr"/>
        <c:lblOffset val="100"/>
        <c:noMultiLvlLbl val="0"/>
      </c:catAx>
      <c:valAx>
        <c:axId val="467044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04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376-4278-AB8F-EFDFD60B3EC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376-4278-AB8F-EFDFD60B3EC6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376-4278-AB8F-EFDFD60B3EC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C376-4278-AB8F-EFDFD60B3EC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376-4278-AB8F-EFDFD60B3EC6}"/>
              </c:ext>
            </c:extLst>
          </c:dPt>
          <c:errBars>
            <c:errBarType val="plus"/>
            <c:errValType val="cust"/>
            <c:noEndCap val="0"/>
            <c:plus>
              <c:numRef>
                <c:f>'IkBa bActin'!$P$3:$P$7</c:f>
                <c:numCache>
                  <c:formatCode>General</c:formatCode>
                  <c:ptCount val="5"/>
                  <c:pt idx="0">
                    <c:v>7.8806953400619661E-2</c:v>
                  </c:pt>
                  <c:pt idx="1">
                    <c:v>1.263601605412998E-2</c:v>
                  </c:pt>
                  <c:pt idx="2">
                    <c:v>0.20478042534548496</c:v>
                  </c:pt>
                  <c:pt idx="3">
                    <c:v>0.33718598242738901</c:v>
                  </c:pt>
                  <c:pt idx="4">
                    <c:v>0.26678132957907491</c:v>
                  </c:pt>
                </c:numCache>
              </c:numRef>
            </c:plus>
            <c:minus>
              <c:numRef>
                <c:f>'IkBa bActin'!$P$3:$P$7</c:f>
                <c:numCache>
                  <c:formatCode>General</c:formatCode>
                  <c:ptCount val="5"/>
                  <c:pt idx="0">
                    <c:v>7.8806953400619661E-2</c:v>
                  </c:pt>
                  <c:pt idx="1">
                    <c:v>1.263601605412998E-2</c:v>
                  </c:pt>
                  <c:pt idx="2">
                    <c:v>0.20478042534548496</c:v>
                  </c:pt>
                  <c:pt idx="3">
                    <c:v>0.33718598242738901</c:v>
                  </c:pt>
                  <c:pt idx="4">
                    <c:v>0.266781329579074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IkBa bActin'!$N$3:$N$7</c:f>
              <c:numCache>
                <c:formatCode>General</c:formatCode>
                <c:ptCount val="5"/>
                <c:pt idx="0">
                  <c:v>4.6001590390886822</c:v>
                </c:pt>
                <c:pt idx="1">
                  <c:v>1</c:v>
                </c:pt>
                <c:pt idx="2">
                  <c:v>4.1292988705584426</c:v>
                </c:pt>
                <c:pt idx="3">
                  <c:v>5.3354603899436643</c:v>
                </c:pt>
                <c:pt idx="4">
                  <c:v>5.79618721133193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76-4278-AB8F-EFDFD60B3E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683619472"/>
        <c:axId val="683611272"/>
      </c:barChart>
      <c:catAx>
        <c:axId val="68361947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83611272"/>
        <c:crosses val="autoZero"/>
        <c:auto val="1"/>
        <c:lblAlgn val="ctr"/>
        <c:lblOffset val="100"/>
        <c:noMultiLvlLbl val="0"/>
      </c:catAx>
      <c:valAx>
        <c:axId val="683611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83619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531-43F2-B644-DB3AEE4B823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D531-43F2-B644-DB3AEE4B823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531-43F2-B644-DB3AEE4B8235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D531-43F2-B644-DB3AEE4B8235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531-43F2-B644-DB3AEE4B8235}"/>
              </c:ext>
            </c:extLst>
          </c:dPt>
          <c:errBars>
            <c:errBarType val="plus"/>
            <c:errValType val="cust"/>
            <c:noEndCap val="0"/>
            <c:plus>
              <c:numRef>
                <c:f>'ERK2 western'!$P$3:$P$7</c:f>
                <c:numCache>
                  <c:formatCode>General</c:formatCode>
                  <c:ptCount val="5"/>
                  <c:pt idx="0">
                    <c:v>0.21624171216553006</c:v>
                  </c:pt>
                  <c:pt idx="1">
                    <c:v>0.10683684698610171</c:v>
                  </c:pt>
                  <c:pt idx="2">
                    <c:v>0.26811304653551388</c:v>
                  </c:pt>
                  <c:pt idx="3">
                    <c:v>0.21814181627260457</c:v>
                  </c:pt>
                  <c:pt idx="4">
                    <c:v>6.7332260192020793E-2</c:v>
                  </c:pt>
                </c:numCache>
              </c:numRef>
            </c:plus>
            <c:minus>
              <c:numRef>
                <c:f>'ERK2 western'!$P$3:$P$7</c:f>
                <c:numCache>
                  <c:formatCode>General</c:formatCode>
                  <c:ptCount val="5"/>
                  <c:pt idx="0">
                    <c:v>0.21624171216553006</c:v>
                  </c:pt>
                  <c:pt idx="1">
                    <c:v>0.10683684698610171</c:v>
                  </c:pt>
                  <c:pt idx="2">
                    <c:v>0.26811304653551388</c:v>
                  </c:pt>
                  <c:pt idx="3">
                    <c:v>0.21814181627260457</c:v>
                  </c:pt>
                  <c:pt idx="4">
                    <c:v>6.73322601920207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ERK2 western'!$N$3:$N$7</c:f>
              <c:numCache>
                <c:formatCode>General</c:formatCode>
                <c:ptCount val="5"/>
                <c:pt idx="0">
                  <c:v>0.47572100960010821</c:v>
                </c:pt>
                <c:pt idx="1">
                  <c:v>1</c:v>
                </c:pt>
                <c:pt idx="2">
                  <c:v>0.63125270071359751</c:v>
                </c:pt>
                <c:pt idx="3">
                  <c:v>0.5417726056363048</c:v>
                </c:pt>
                <c:pt idx="4">
                  <c:v>0.562259531513877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31-43F2-B644-DB3AEE4B82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475287080"/>
        <c:axId val="475283800"/>
      </c:barChart>
      <c:catAx>
        <c:axId val="4752870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5283800"/>
        <c:crosses val="autoZero"/>
        <c:auto val="1"/>
        <c:lblAlgn val="ctr"/>
        <c:lblOffset val="100"/>
        <c:noMultiLvlLbl val="0"/>
      </c:catAx>
      <c:valAx>
        <c:axId val="475283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75287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319BF0-5552-48B7-AF43-33E1193AB7CA}" type="datetimeFigureOut">
              <a:rPr kumimoji="1" lang="ja-JP" altLang="en-US" smtClean="0"/>
              <a:pPr/>
              <a:t>2017/12/25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46125"/>
            <a:ext cx="25781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9824E-F26B-4031-80D0-C3247E9BC8A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3DF4A2-E107-4F73-A161-6BD97D5E234B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385CDF-3608-4544-B6D3-D00287C07F6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1508E0-4886-457B-9CD1-05D17D8E056D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1AE41-838F-4ACE-BEDA-2A8A25ECC27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E2C25A-41ED-4D69-A086-29B695AB19BA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D3E8FF-E690-4C77-A5AF-69EBC1D4A3C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73DF29-2CE6-4117-A95F-D876451CB73C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80A3F0-0CFC-4756-9841-BF6E02A8492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43021A-FD8A-4F4F-B6D8-7B14B853B367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B4664-3AF6-460B-BBBD-78E3154569E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651F61-4B11-488B-9008-8086F5E2DB67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95DEAE-B4B7-40B7-A6C8-4F60850ACDC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8D95B9-37E7-4F9C-BDB1-909ECE315A77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C8C682-1F8C-4283-80F3-FEFE478CB15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202ABC-D2EF-4C7D-8E38-6FA8D9AEF023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53F9DA-BC0E-44C9-BF41-65085A2B3A8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724221-09E7-440C-9389-D5CF79A7945D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5D4617-0EF3-48C0-9FED-16916EEADC1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BD1E29-E673-4A57-8D5D-819D4035C619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57DD9A-7338-4C34-A40A-4C26E9F1665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465504-01A1-41B1-A4A6-7EF66721E5D3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7C8C3A-DC80-4809-A194-A767A624995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77D3687F-29B5-437B-86CB-9077F9756D80}" type="datetimeFigureOut">
              <a:rPr lang="ja-JP" altLang="en-US"/>
              <a:pPr>
                <a:defRPr/>
              </a:pPr>
              <a:t>2017/12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4F12624-508F-4F68-A797-DFD7B5B3540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3">
            <a:extLst>
              <a:ext uri="{FF2B5EF4-FFF2-40B4-BE49-F238E27FC236}">
                <a16:creationId xmlns:a16="http://schemas.microsoft.com/office/drawing/2014/main" id="{0E3D7C2F-2D4F-4434-9434-16ED4F20DE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9536113"/>
            <a:ext cx="32400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b="1" dirty="0" err="1">
                <a:cs typeface="Arial" charset="0"/>
              </a:rPr>
              <a:t>Sup.fig</a:t>
            </a:r>
            <a:r>
              <a:rPr lang="en-US" altLang="ja-JP" b="1" dirty="0">
                <a:cs typeface="Arial" charset="0"/>
              </a:rPr>
              <a:t>. 2</a:t>
            </a:r>
          </a:p>
        </p:txBody>
      </p:sp>
      <p:sp>
        <p:nvSpPr>
          <p:cNvPr id="3" name="テキスト ボックス 4">
            <a:extLst>
              <a:ext uri="{FF2B5EF4-FFF2-40B4-BE49-F238E27FC236}">
                <a16:creationId xmlns:a16="http://schemas.microsoft.com/office/drawing/2014/main" id="{1D42DF6B-5B1A-4A51-BF43-3D9BC4EEF6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37" y="704850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A</a:t>
            </a:r>
            <a:endParaRPr lang="ja-JP" altLang="en-US" sz="2400" b="1" dirty="0">
              <a:cs typeface="Arial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A3662B43-6E55-45CE-BE91-4E9309E300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4470052"/>
              </p:ext>
            </p:extLst>
          </p:nvPr>
        </p:nvGraphicFramePr>
        <p:xfrm>
          <a:off x="404664" y="1028725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0B4CF5C-BCAB-4707-ADC2-B53A04ECD6D1}"/>
              </a:ext>
            </a:extLst>
          </p:cNvPr>
          <p:cNvSpPr txBox="1"/>
          <p:nvPr/>
        </p:nvSpPr>
        <p:spPr>
          <a:xfrm rot="16200000">
            <a:off x="-624354" y="1741630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P-JNK1/JNK1 ratio</a:t>
            </a:r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BA6BA2C7-8150-454D-AB76-0403441B344B}"/>
              </a:ext>
            </a:extLst>
          </p:cNvPr>
          <p:cNvGrpSpPr/>
          <p:nvPr/>
        </p:nvGrpSpPr>
        <p:grpSpPr>
          <a:xfrm>
            <a:off x="620744" y="2544775"/>
            <a:ext cx="1656128" cy="567978"/>
            <a:chOff x="620744" y="2544775"/>
            <a:chExt cx="1656128" cy="567978"/>
          </a:xfrm>
        </p:grpSpPr>
        <p:sp>
          <p:nvSpPr>
            <p:cNvPr id="8" name="テキスト ボックス 1">
              <a:extLst>
                <a:ext uri="{FF2B5EF4-FFF2-40B4-BE49-F238E27FC236}">
                  <a16:creationId xmlns:a16="http://schemas.microsoft.com/office/drawing/2014/main" id="{6935B09E-43FE-452F-9C02-A09B3C025FAB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D80A473A-0EB2-4961-82C8-4B2B88EFAF6E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">
              <a:extLst>
                <a:ext uri="{FF2B5EF4-FFF2-40B4-BE49-F238E27FC236}">
                  <a16:creationId xmlns:a16="http://schemas.microsoft.com/office/drawing/2014/main" id="{FD851DAE-55D4-4433-AE24-5415948EEFB5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6DA0C0FF-023E-4B08-AC3D-2899FDEFC53E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テキスト ボックス 1">
              <a:extLst>
                <a:ext uri="{FF2B5EF4-FFF2-40B4-BE49-F238E27FC236}">
                  <a16:creationId xmlns:a16="http://schemas.microsoft.com/office/drawing/2014/main" id="{5699C206-0D6D-4D3D-8BB9-47C925B226FE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テキスト ボックス 1">
              <a:extLst>
                <a:ext uri="{FF2B5EF4-FFF2-40B4-BE49-F238E27FC236}">
                  <a16:creationId xmlns:a16="http://schemas.microsoft.com/office/drawing/2014/main" id="{95D4BA10-5277-47AC-8A5C-371CE8B81CAC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">
              <a:extLst>
                <a:ext uri="{FF2B5EF4-FFF2-40B4-BE49-F238E27FC236}">
                  <a16:creationId xmlns:a16="http://schemas.microsoft.com/office/drawing/2014/main" id="{ABC0512F-9893-45BC-B8BB-B61C26456918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テキスト ボックス 1">
              <a:extLst>
                <a:ext uri="{FF2B5EF4-FFF2-40B4-BE49-F238E27FC236}">
                  <a16:creationId xmlns:a16="http://schemas.microsoft.com/office/drawing/2014/main" id="{D15263A8-FB93-4022-8433-7AE2FC94210E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A0E3A27B-A7D5-4C0D-ABF7-AA8C4F3B09C2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テキスト ボックス 1">
            <a:extLst>
              <a:ext uri="{FF2B5EF4-FFF2-40B4-BE49-F238E27FC236}">
                <a16:creationId xmlns:a16="http://schemas.microsoft.com/office/drawing/2014/main" id="{6CA5A9E7-FE17-4156-914D-426DEC1E89C0}"/>
              </a:ext>
            </a:extLst>
          </p:cNvPr>
          <p:cNvSpPr txBox="1"/>
          <p:nvPr/>
        </p:nvSpPr>
        <p:spPr>
          <a:xfrm>
            <a:off x="620688" y="2278828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">
            <a:extLst>
              <a:ext uri="{FF2B5EF4-FFF2-40B4-BE49-F238E27FC236}">
                <a16:creationId xmlns:a16="http://schemas.microsoft.com/office/drawing/2014/main" id="{CCEA7614-1340-49A1-95FC-B6D08377AC9F}"/>
              </a:ext>
            </a:extLst>
          </p:cNvPr>
          <p:cNvSpPr txBox="1"/>
          <p:nvPr/>
        </p:nvSpPr>
        <p:spPr>
          <a:xfrm>
            <a:off x="1152000" y="2016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2823E835-FC75-4A90-9607-617A8A0CBD80}"/>
              </a:ext>
            </a:extLst>
          </p:cNvPr>
          <p:cNvSpPr txBox="1"/>
          <p:nvPr/>
        </p:nvSpPr>
        <p:spPr>
          <a:xfrm>
            <a:off x="1412776" y="2160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テキスト ボックス 1">
            <a:extLst>
              <a:ext uri="{FF2B5EF4-FFF2-40B4-BE49-F238E27FC236}">
                <a16:creationId xmlns:a16="http://schemas.microsoft.com/office/drawing/2014/main" id="{C5CC3596-4E52-4ECF-97DC-E0786389BDDE}"/>
              </a:ext>
            </a:extLst>
          </p:cNvPr>
          <p:cNvSpPr txBox="1"/>
          <p:nvPr/>
        </p:nvSpPr>
        <p:spPr>
          <a:xfrm>
            <a:off x="1674000" y="2232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1221636E-6CCB-4762-B892-9C00AC89CE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4575569"/>
              </p:ext>
            </p:extLst>
          </p:nvPr>
        </p:nvGraphicFramePr>
        <p:xfrm>
          <a:off x="2420888" y="1044000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テキスト ボックス 12">
            <a:extLst>
              <a:ext uri="{FF2B5EF4-FFF2-40B4-BE49-F238E27FC236}">
                <a16:creationId xmlns:a16="http://schemas.microsoft.com/office/drawing/2014/main" id="{A70A1DA6-00F1-4F54-BD15-957D710638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4864" y="704850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B</a:t>
            </a:r>
            <a:endParaRPr lang="ja-JP" altLang="en-US" sz="2400" b="1" dirty="0">
              <a:cs typeface="Arial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0F23B7D-6EFF-4D5A-A2BB-90904AE338BA}"/>
              </a:ext>
            </a:extLst>
          </p:cNvPr>
          <p:cNvSpPr txBox="1"/>
          <p:nvPr/>
        </p:nvSpPr>
        <p:spPr>
          <a:xfrm rot="16200000">
            <a:off x="1433680" y="1733547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P-JNK2,3/JNK2,3 ratio</a:t>
            </a:r>
          </a:p>
        </p:txBody>
      </p:sp>
      <p:sp>
        <p:nvSpPr>
          <p:cNvPr id="35" name="テキスト ボックス 1">
            <a:extLst>
              <a:ext uri="{FF2B5EF4-FFF2-40B4-BE49-F238E27FC236}">
                <a16:creationId xmlns:a16="http://schemas.microsoft.com/office/drawing/2014/main" id="{FF82F85F-599F-46F1-8E8C-C8FDA25A5B0B}"/>
              </a:ext>
            </a:extLst>
          </p:cNvPr>
          <p:cNvSpPr txBox="1"/>
          <p:nvPr/>
        </p:nvSpPr>
        <p:spPr>
          <a:xfrm>
            <a:off x="2636912" y="2278828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テキスト ボックス 1">
            <a:extLst>
              <a:ext uri="{FF2B5EF4-FFF2-40B4-BE49-F238E27FC236}">
                <a16:creationId xmlns:a16="http://schemas.microsoft.com/office/drawing/2014/main" id="{EF1C95F0-ED59-430F-A242-3DCA82E1056D}"/>
              </a:ext>
            </a:extLst>
          </p:cNvPr>
          <p:cNvSpPr txBox="1"/>
          <p:nvPr/>
        </p:nvSpPr>
        <p:spPr>
          <a:xfrm>
            <a:off x="3168000" y="1980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テキスト ボックス 1">
            <a:extLst>
              <a:ext uri="{FF2B5EF4-FFF2-40B4-BE49-F238E27FC236}">
                <a16:creationId xmlns:a16="http://schemas.microsoft.com/office/drawing/2014/main" id="{0BE3741B-BB92-451A-9CE7-CCD6683C2E0B}"/>
              </a:ext>
            </a:extLst>
          </p:cNvPr>
          <p:cNvSpPr txBox="1"/>
          <p:nvPr/>
        </p:nvSpPr>
        <p:spPr>
          <a:xfrm>
            <a:off x="3429000" y="2144688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テキスト ボックス 1">
            <a:extLst>
              <a:ext uri="{FF2B5EF4-FFF2-40B4-BE49-F238E27FC236}">
                <a16:creationId xmlns:a16="http://schemas.microsoft.com/office/drawing/2014/main" id="{543A3586-04A7-481F-9664-D2CCC6310FAC}"/>
              </a:ext>
            </a:extLst>
          </p:cNvPr>
          <p:cNvSpPr txBox="1"/>
          <p:nvPr/>
        </p:nvSpPr>
        <p:spPr>
          <a:xfrm>
            <a:off x="3690000" y="2268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テキスト ボックス 4">
            <a:extLst>
              <a:ext uri="{FF2B5EF4-FFF2-40B4-BE49-F238E27FC236}">
                <a16:creationId xmlns:a16="http://schemas.microsoft.com/office/drawing/2014/main" id="{55D8E2BD-2354-4758-9308-0C559AD6A1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37" y="3194893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C</a:t>
            </a:r>
            <a:endParaRPr lang="ja-JP" altLang="en-US" sz="2400" b="1" dirty="0">
              <a:cs typeface="Arial" charset="0"/>
            </a:endParaRPr>
          </a:p>
        </p:txBody>
      </p:sp>
      <p:sp>
        <p:nvSpPr>
          <p:cNvPr id="40" name="テキスト ボックス 4">
            <a:extLst>
              <a:ext uri="{FF2B5EF4-FFF2-40B4-BE49-F238E27FC236}">
                <a16:creationId xmlns:a16="http://schemas.microsoft.com/office/drawing/2014/main" id="{7F282A3C-3E59-4FC9-9E96-DE8FCD37D3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6872" y="3194893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D</a:t>
            </a:r>
            <a:endParaRPr lang="ja-JP" altLang="en-US" sz="2400" b="1" dirty="0">
              <a:cs typeface="Arial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0AF0AEFD-DE51-42A9-9F43-88E0D18C5A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1125919"/>
              </p:ext>
            </p:extLst>
          </p:nvPr>
        </p:nvGraphicFramePr>
        <p:xfrm>
          <a:off x="404664" y="3512840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16C20FC-4D8A-48F6-938B-3A94F58A399A}"/>
              </a:ext>
            </a:extLst>
          </p:cNvPr>
          <p:cNvSpPr txBox="1"/>
          <p:nvPr/>
        </p:nvSpPr>
        <p:spPr>
          <a:xfrm rot="16200000">
            <a:off x="-624354" y="4181816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P-ERK1/ERK1 ratio</a:t>
            </a:r>
          </a:p>
        </p:txBody>
      </p:sp>
      <p:sp>
        <p:nvSpPr>
          <p:cNvPr id="52" name="テキスト ボックス 1">
            <a:extLst>
              <a:ext uri="{FF2B5EF4-FFF2-40B4-BE49-F238E27FC236}">
                <a16:creationId xmlns:a16="http://schemas.microsoft.com/office/drawing/2014/main" id="{622E4410-A503-4799-8409-0F2BAE9497D1}"/>
              </a:ext>
            </a:extLst>
          </p:cNvPr>
          <p:cNvSpPr txBox="1"/>
          <p:nvPr/>
        </p:nvSpPr>
        <p:spPr>
          <a:xfrm>
            <a:off x="620688" y="4050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1">
            <a:extLst>
              <a:ext uri="{FF2B5EF4-FFF2-40B4-BE49-F238E27FC236}">
                <a16:creationId xmlns:a16="http://schemas.microsoft.com/office/drawing/2014/main" id="{AB741FF0-5C48-4685-B0A2-B8A220336A40}"/>
              </a:ext>
            </a:extLst>
          </p:cNvPr>
          <p:cNvSpPr txBox="1"/>
          <p:nvPr/>
        </p:nvSpPr>
        <p:spPr>
          <a:xfrm>
            <a:off x="1674000" y="4160912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1A8C7A6-540D-40F4-BE90-E94524B218CE}"/>
              </a:ext>
            </a:extLst>
          </p:cNvPr>
          <p:cNvSpPr txBox="1"/>
          <p:nvPr/>
        </p:nvSpPr>
        <p:spPr>
          <a:xfrm rot="16200000">
            <a:off x="1433680" y="4181819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P-ERK2/ERK2 ratio</a:t>
            </a:r>
          </a:p>
        </p:txBody>
      </p:sp>
      <p:sp>
        <p:nvSpPr>
          <p:cNvPr id="65" name="テキスト ボックス 4">
            <a:extLst>
              <a:ext uri="{FF2B5EF4-FFF2-40B4-BE49-F238E27FC236}">
                <a16:creationId xmlns:a16="http://schemas.microsoft.com/office/drawing/2014/main" id="{33B4628B-621E-426B-B50D-23377B77DD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37" y="5673080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E</a:t>
            </a:r>
            <a:endParaRPr lang="ja-JP" altLang="en-US" sz="2400" b="1" dirty="0">
              <a:cs typeface="Arial" charset="0"/>
            </a:endParaRPr>
          </a:p>
        </p:txBody>
      </p:sp>
      <p:sp>
        <p:nvSpPr>
          <p:cNvPr id="66" name="テキスト ボックス 4">
            <a:extLst>
              <a:ext uri="{FF2B5EF4-FFF2-40B4-BE49-F238E27FC236}">
                <a16:creationId xmlns:a16="http://schemas.microsoft.com/office/drawing/2014/main" id="{ADD480AC-9B51-4A87-88BC-DA7CE48F78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8880" y="5673080"/>
            <a:ext cx="549275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2400" b="1" dirty="0">
                <a:cs typeface="Arial" charset="0"/>
              </a:rPr>
              <a:t>F</a:t>
            </a:r>
            <a:endParaRPr lang="ja-JP" altLang="en-US" sz="2400" b="1" dirty="0">
              <a:cs typeface="Arial" charset="0"/>
            </a:endParaRPr>
          </a:p>
        </p:txBody>
      </p:sp>
      <p:graphicFrame>
        <p:nvGraphicFramePr>
          <p:cNvPr id="67" name="グラフ 66">
            <a:extLst>
              <a:ext uri="{FF2B5EF4-FFF2-40B4-BE49-F238E27FC236}">
                <a16:creationId xmlns:a16="http://schemas.microsoft.com/office/drawing/2014/main" id="{3BBE64A1-92C0-4F30-A735-9A6E498DF2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6726361"/>
              </p:ext>
            </p:extLst>
          </p:nvPr>
        </p:nvGraphicFramePr>
        <p:xfrm>
          <a:off x="404664" y="6033120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8FC637E2-59A2-4BFB-BBD7-8ADF0E1C87B6}"/>
              </a:ext>
            </a:extLst>
          </p:cNvPr>
          <p:cNvSpPr txBox="1"/>
          <p:nvPr/>
        </p:nvSpPr>
        <p:spPr>
          <a:xfrm rot="16200000">
            <a:off x="-624354" y="6702096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P-p38/p38 ratio</a:t>
            </a:r>
          </a:p>
        </p:txBody>
      </p:sp>
      <p:sp>
        <p:nvSpPr>
          <p:cNvPr id="69" name="テキスト ボックス 1">
            <a:extLst>
              <a:ext uri="{FF2B5EF4-FFF2-40B4-BE49-F238E27FC236}">
                <a16:creationId xmlns:a16="http://schemas.microsoft.com/office/drawing/2014/main" id="{FC5A5A62-A7BA-4083-B229-9719C70B4C72}"/>
              </a:ext>
            </a:extLst>
          </p:cNvPr>
          <p:cNvSpPr txBox="1"/>
          <p:nvPr/>
        </p:nvSpPr>
        <p:spPr>
          <a:xfrm>
            <a:off x="620688" y="7074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テキスト ボックス 1">
            <a:extLst>
              <a:ext uri="{FF2B5EF4-FFF2-40B4-BE49-F238E27FC236}">
                <a16:creationId xmlns:a16="http://schemas.microsoft.com/office/drawing/2014/main" id="{EFABF3E1-0783-4CC0-B34A-03F0A6296819}"/>
              </a:ext>
            </a:extLst>
          </p:cNvPr>
          <p:cNvSpPr txBox="1"/>
          <p:nvPr/>
        </p:nvSpPr>
        <p:spPr>
          <a:xfrm>
            <a:off x="1152000" y="6768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テキスト ボックス 1">
            <a:extLst>
              <a:ext uri="{FF2B5EF4-FFF2-40B4-BE49-F238E27FC236}">
                <a16:creationId xmlns:a16="http://schemas.microsoft.com/office/drawing/2014/main" id="{C59F460C-FF0D-4D20-9E52-8ADA2E21CD8D}"/>
              </a:ext>
            </a:extLst>
          </p:cNvPr>
          <p:cNvSpPr txBox="1"/>
          <p:nvPr/>
        </p:nvSpPr>
        <p:spPr>
          <a:xfrm>
            <a:off x="1412776" y="6825208"/>
            <a:ext cx="504056" cy="28803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テキスト ボックス 1">
            <a:extLst>
              <a:ext uri="{FF2B5EF4-FFF2-40B4-BE49-F238E27FC236}">
                <a16:creationId xmlns:a16="http://schemas.microsoft.com/office/drawing/2014/main" id="{DA6A731F-91ED-4F42-A8D0-1DE25C1D5700}"/>
              </a:ext>
            </a:extLst>
          </p:cNvPr>
          <p:cNvSpPr txBox="1"/>
          <p:nvPr/>
        </p:nvSpPr>
        <p:spPr>
          <a:xfrm>
            <a:off x="1674000" y="6786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2" name="グラフ 81">
            <a:extLst>
              <a:ext uri="{FF2B5EF4-FFF2-40B4-BE49-F238E27FC236}">
                <a16:creationId xmlns:a16="http://schemas.microsoft.com/office/drawing/2014/main" id="{E36715D5-6E83-493A-99AA-88C71B4F93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3019560"/>
              </p:ext>
            </p:extLst>
          </p:nvPr>
        </p:nvGraphicFramePr>
        <p:xfrm>
          <a:off x="2492896" y="6033320"/>
          <a:ext cx="1728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3" name="テキスト ボックス 1">
            <a:extLst>
              <a:ext uri="{FF2B5EF4-FFF2-40B4-BE49-F238E27FC236}">
                <a16:creationId xmlns:a16="http://schemas.microsoft.com/office/drawing/2014/main" id="{E714F0F1-BE0E-4581-B45C-BB2E733148EE}"/>
              </a:ext>
            </a:extLst>
          </p:cNvPr>
          <p:cNvSpPr txBox="1"/>
          <p:nvPr/>
        </p:nvSpPr>
        <p:spPr>
          <a:xfrm>
            <a:off x="2620800" y="6408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テキスト ボックス 1">
            <a:extLst>
              <a:ext uri="{FF2B5EF4-FFF2-40B4-BE49-F238E27FC236}">
                <a16:creationId xmlns:a16="http://schemas.microsoft.com/office/drawing/2014/main" id="{4477138B-660B-426A-864D-F28A95609715}"/>
              </a:ext>
            </a:extLst>
          </p:cNvPr>
          <p:cNvSpPr txBox="1"/>
          <p:nvPr/>
        </p:nvSpPr>
        <p:spPr>
          <a:xfrm>
            <a:off x="3150000" y="6480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テキスト ボックス 1">
            <a:extLst>
              <a:ext uri="{FF2B5EF4-FFF2-40B4-BE49-F238E27FC236}">
                <a16:creationId xmlns:a16="http://schemas.microsoft.com/office/drawing/2014/main" id="{7698E4C8-D502-403B-92D2-40884F26702D}"/>
              </a:ext>
            </a:extLst>
          </p:cNvPr>
          <p:cNvSpPr txBox="1"/>
          <p:nvPr/>
        </p:nvSpPr>
        <p:spPr>
          <a:xfrm>
            <a:off x="3429000" y="6228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テキスト ボックス 1">
            <a:extLst>
              <a:ext uri="{FF2B5EF4-FFF2-40B4-BE49-F238E27FC236}">
                <a16:creationId xmlns:a16="http://schemas.microsoft.com/office/drawing/2014/main" id="{B6A04245-F46B-46D6-B7B7-9F96AB7CC9D8}"/>
              </a:ext>
            </a:extLst>
          </p:cNvPr>
          <p:cNvSpPr txBox="1"/>
          <p:nvPr/>
        </p:nvSpPr>
        <p:spPr>
          <a:xfrm>
            <a:off x="3690000" y="6156000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9C9D504-B337-490B-9769-13E4AD3688F2}"/>
              </a:ext>
            </a:extLst>
          </p:cNvPr>
          <p:cNvSpPr txBox="1"/>
          <p:nvPr/>
        </p:nvSpPr>
        <p:spPr>
          <a:xfrm rot="16200000">
            <a:off x="1505688" y="6702099"/>
            <a:ext cx="1872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 err="1"/>
              <a:t>I</a:t>
            </a:r>
            <a:r>
              <a:rPr lang="en-US" altLang="ja-JP" sz="1000" dirty="0" err="1">
                <a:latin typeface="Symbol" panose="05050102010706020507" pitchFamily="18" charset="2"/>
              </a:rPr>
              <a:t>k</a:t>
            </a:r>
            <a:r>
              <a:rPr lang="en-US" altLang="ja-JP" sz="1000" dirty="0" err="1"/>
              <a:t>B</a:t>
            </a:r>
            <a:r>
              <a:rPr lang="en-US" altLang="ja-JP" sz="1000" dirty="0"/>
              <a:t>-</a:t>
            </a:r>
            <a:r>
              <a:rPr lang="en-US" altLang="ja-JP" sz="1000" dirty="0">
                <a:latin typeface="Symbol" panose="05050102010706020507" pitchFamily="18" charset="2"/>
              </a:rPr>
              <a:t>a</a:t>
            </a:r>
            <a:r>
              <a:rPr lang="en-US" altLang="ja-JP" sz="1000" dirty="0"/>
              <a:t>/B-Actin ratio</a:t>
            </a:r>
          </a:p>
        </p:txBody>
      </p:sp>
      <p:graphicFrame>
        <p:nvGraphicFramePr>
          <p:cNvPr id="98" name="グラフ 97">
            <a:extLst>
              <a:ext uri="{FF2B5EF4-FFF2-40B4-BE49-F238E27FC236}">
                <a16:creationId xmlns:a16="http://schemas.microsoft.com/office/drawing/2014/main" id="{689C7584-E128-4CE0-A178-9AE279642F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783686"/>
              </p:ext>
            </p:extLst>
          </p:nvPr>
        </p:nvGraphicFramePr>
        <p:xfrm>
          <a:off x="2421088" y="3512840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9" name="テキスト ボックス 1">
            <a:extLst>
              <a:ext uri="{FF2B5EF4-FFF2-40B4-BE49-F238E27FC236}">
                <a16:creationId xmlns:a16="http://schemas.microsoft.com/office/drawing/2014/main" id="{EA18C6D2-1FF6-4B25-98C0-BE8214E20E44}"/>
              </a:ext>
            </a:extLst>
          </p:cNvPr>
          <p:cNvSpPr txBox="1"/>
          <p:nvPr/>
        </p:nvSpPr>
        <p:spPr>
          <a:xfrm>
            <a:off x="2636912" y="4016896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テキスト ボックス 1">
            <a:extLst>
              <a:ext uri="{FF2B5EF4-FFF2-40B4-BE49-F238E27FC236}">
                <a16:creationId xmlns:a16="http://schemas.microsoft.com/office/drawing/2014/main" id="{F559FE68-CC48-4A99-B600-9AC181C79112}"/>
              </a:ext>
            </a:extLst>
          </p:cNvPr>
          <p:cNvSpPr txBox="1"/>
          <p:nvPr/>
        </p:nvSpPr>
        <p:spPr>
          <a:xfrm>
            <a:off x="3690000" y="4088904"/>
            <a:ext cx="504056" cy="2979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200" dirty="0">
                <a:latin typeface="Arial" pitchFamily="34" charset="0"/>
                <a:cs typeface="Arial" pitchFamily="34" charset="0"/>
              </a:rPr>
              <a:t>*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CD328E9F-3F6F-4A2D-B03C-750FC3734395}"/>
              </a:ext>
            </a:extLst>
          </p:cNvPr>
          <p:cNvGrpSpPr/>
          <p:nvPr/>
        </p:nvGrpSpPr>
        <p:grpSpPr>
          <a:xfrm>
            <a:off x="2636968" y="2556000"/>
            <a:ext cx="1656128" cy="567978"/>
            <a:chOff x="620744" y="2544775"/>
            <a:chExt cx="1656128" cy="567978"/>
          </a:xfrm>
        </p:grpSpPr>
        <p:sp>
          <p:nvSpPr>
            <p:cNvPr id="103" name="テキスト ボックス 1">
              <a:extLst>
                <a:ext uri="{FF2B5EF4-FFF2-40B4-BE49-F238E27FC236}">
                  <a16:creationId xmlns:a16="http://schemas.microsoft.com/office/drawing/2014/main" id="{2F75B980-E75D-4120-9683-E9A6CE2EF253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5AC068F4-FD25-49CD-BE7C-A820E722939E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テキスト ボックス 1">
              <a:extLst>
                <a:ext uri="{FF2B5EF4-FFF2-40B4-BE49-F238E27FC236}">
                  <a16:creationId xmlns:a16="http://schemas.microsoft.com/office/drawing/2014/main" id="{F15C7E13-5243-45CA-A5F1-D385C57C0511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95CFA6AD-91C4-4D58-9E5E-625232AA56BD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7" name="テキスト ボックス 1">
              <a:extLst>
                <a:ext uri="{FF2B5EF4-FFF2-40B4-BE49-F238E27FC236}">
                  <a16:creationId xmlns:a16="http://schemas.microsoft.com/office/drawing/2014/main" id="{9B9061B7-73CF-46B3-A98F-474AF7DC93A1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テキスト ボックス 1">
              <a:extLst>
                <a:ext uri="{FF2B5EF4-FFF2-40B4-BE49-F238E27FC236}">
                  <a16:creationId xmlns:a16="http://schemas.microsoft.com/office/drawing/2014/main" id="{94FDAE88-BB62-4052-9BBC-5E088B6C9459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テキスト ボックス 1">
              <a:extLst>
                <a:ext uri="{FF2B5EF4-FFF2-40B4-BE49-F238E27FC236}">
                  <a16:creationId xmlns:a16="http://schemas.microsoft.com/office/drawing/2014/main" id="{1863481B-F26E-4257-941D-85C54F040F41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テキスト ボックス 1">
              <a:extLst>
                <a:ext uri="{FF2B5EF4-FFF2-40B4-BE49-F238E27FC236}">
                  <a16:creationId xmlns:a16="http://schemas.microsoft.com/office/drawing/2014/main" id="{E394F1FF-1A00-4C7B-AFDB-6313DCA0C051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38E2C6F9-7E6D-40EF-864C-19EC7BEEE70E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EC511EEC-79B7-42BF-B739-D85D80DE7012}"/>
              </a:ext>
            </a:extLst>
          </p:cNvPr>
          <p:cNvGrpSpPr/>
          <p:nvPr/>
        </p:nvGrpSpPr>
        <p:grpSpPr>
          <a:xfrm>
            <a:off x="620688" y="5025008"/>
            <a:ext cx="1656128" cy="567978"/>
            <a:chOff x="620744" y="2544775"/>
            <a:chExt cx="1656128" cy="567978"/>
          </a:xfrm>
        </p:grpSpPr>
        <p:sp>
          <p:nvSpPr>
            <p:cNvPr id="113" name="テキスト ボックス 1">
              <a:extLst>
                <a:ext uri="{FF2B5EF4-FFF2-40B4-BE49-F238E27FC236}">
                  <a16:creationId xmlns:a16="http://schemas.microsoft.com/office/drawing/2014/main" id="{8AF17770-ABC1-4D1E-B134-B038ED20FAD4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8F04206C-1E4A-4B9F-817F-521D0ECAF7DA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テキスト ボックス 1">
              <a:extLst>
                <a:ext uri="{FF2B5EF4-FFF2-40B4-BE49-F238E27FC236}">
                  <a16:creationId xmlns:a16="http://schemas.microsoft.com/office/drawing/2014/main" id="{565F2893-A8F4-46EC-83BD-0725C7D4325F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78A44DE5-0CD7-4DE7-94A3-2DA99BF45CBF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7" name="テキスト ボックス 1">
              <a:extLst>
                <a:ext uri="{FF2B5EF4-FFF2-40B4-BE49-F238E27FC236}">
                  <a16:creationId xmlns:a16="http://schemas.microsoft.com/office/drawing/2014/main" id="{33A607C7-E6AC-4248-A52E-C99BFD5DD358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テキスト ボックス 1">
              <a:extLst>
                <a:ext uri="{FF2B5EF4-FFF2-40B4-BE49-F238E27FC236}">
                  <a16:creationId xmlns:a16="http://schemas.microsoft.com/office/drawing/2014/main" id="{618EC12D-F032-491D-BFAD-92DA1E93712F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テキスト ボックス 1">
              <a:extLst>
                <a:ext uri="{FF2B5EF4-FFF2-40B4-BE49-F238E27FC236}">
                  <a16:creationId xmlns:a16="http://schemas.microsoft.com/office/drawing/2014/main" id="{32C772B5-065C-456E-B738-37E240FD45F9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テキスト ボックス 1">
              <a:extLst>
                <a:ext uri="{FF2B5EF4-FFF2-40B4-BE49-F238E27FC236}">
                  <a16:creationId xmlns:a16="http://schemas.microsoft.com/office/drawing/2014/main" id="{B5D71457-3D93-4117-B641-C280DE5EEF92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4E2FAA99-37FD-4E81-AA9D-9DCB9595FACC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DC6820F5-BEB5-457F-8167-E40A3E9AB909}"/>
              </a:ext>
            </a:extLst>
          </p:cNvPr>
          <p:cNvGrpSpPr/>
          <p:nvPr/>
        </p:nvGrpSpPr>
        <p:grpSpPr>
          <a:xfrm>
            <a:off x="2636968" y="5025008"/>
            <a:ext cx="1656128" cy="567978"/>
            <a:chOff x="620744" y="2544775"/>
            <a:chExt cx="1656128" cy="567978"/>
          </a:xfrm>
        </p:grpSpPr>
        <p:sp>
          <p:nvSpPr>
            <p:cNvPr id="123" name="テキスト ボックス 1">
              <a:extLst>
                <a:ext uri="{FF2B5EF4-FFF2-40B4-BE49-F238E27FC236}">
                  <a16:creationId xmlns:a16="http://schemas.microsoft.com/office/drawing/2014/main" id="{58F7452F-9F02-4EA3-BF14-DD0B4A43F425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BA4DEE1C-2D5D-42A6-AF59-C8760A3293C1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">
              <a:extLst>
                <a:ext uri="{FF2B5EF4-FFF2-40B4-BE49-F238E27FC236}">
                  <a16:creationId xmlns:a16="http://schemas.microsoft.com/office/drawing/2014/main" id="{FC1F35F0-4621-4A0E-AC61-E6C87813E683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正方形/長方形 125">
              <a:extLst>
                <a:ext uri="{FF2B5EF4-FFF2-40B4-BE49-F238E27FC236}">
                  <a16:creationId xmlns:a16="http://schemas.microsoft.com/office/drawing/2014/main" id="{0843C56D-D25B-461F-98B0-0599F709EF54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7" name="テキスト ボックス 1">
              <a:extLst>
                <a:ext uri="{FF2B5EF4-FFF2-40B4-BE49-F238E27FC236}">
                  <a16:creationId xmlns:a16="http://schemas.microsoft.com/office/drawing/2014/main" id="{8512E78E-ECEE-4317-ACC7-04EEAAEFF33A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テキスト ボックス 1">
              <a:extLst>
                <a:ext uri="{FF2B5EF4-FFF2-40B4-BE49-F238E27FC236}">
                  <a16:creationId xmlns:a16="http://schemas.microsoft.com/office/drawing/2014/main" id="{5B415F15-259E-4A14-A1D9-4421B07DA389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テキスト ボックス 1">
              <a:extLst>
                <a:ext uri="{FF2B5EF4-FFF2-40B4-BE49-F238E27FC236}">
                  <a16:creationId xmlns:a16="http://schemas.microsoft.com/office/drawing/2014/main" id="{25A75F0B-69CE-4A5D-B0B7-848EF8F2CF8C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テキスト ボックス 1">
              <a:extLst>
                <a:ext uri="{FF2B5EF4-FFF2-40B4-BE49-F238E27FC236}">
                  <a16:creationId xmlns:a16="http://schemas.microsoft.com/office/drawing/2014/main" id="{C7625CB3-911E-4CF6-B040-F8ECFA9F32A9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1" name="直線コネクタ 130">
              <a:extLst>
                <a:ext uri="{FF2B5EF4-FFF2-40B4-BE49-F238E27FC236}">
                  <a16:creationId xmlns:a16="http://schemas.microsoft.com/office/drawing/2014/main" id="{D6E08F8C-A972-48B5-8098-D03F8328ACAC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id="{F39ADCFA-DDA0-49A3-A465-ED5803B4898C}"/>
              </a:ext>
            </a:extLst>
          </p:cNvPr>
          <p:cNvGrpSpPr/>
          <p:nvPr/>
        </p:nvGrpSpPr>
        <p:grpSpPr>
          <a:xfrm>
            <a:off x="620688" y="7553374"/>
            <a:ext cx="1656128" cy="567978"/>
            <a:chOff x="620744" y="2544775"/>
            <a:chExt cx="1656128" cy="567978"/>
          </a:xfrm>
        </p:grpSpPr>
        <p:sp>
          <p:nvSpPr>
            <p:cNvPr id="133" name="テキスト ボックス 1">
              <a:extLst>
                <a:ext uri="{FF2B5EF4-FFF2-40B4-BE49-F238E27FC236}">
                  <a16:creationId xmlns:a16="http://schemas.microsoft.com/office/drawing/2014/main" id="{EB9982E0-B0F6-4E91-B455-4F02693BAF9A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D327690A-6EA9-4278-96E6-3D99B08BB146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テキスト ボックス 1">
              <a:extLst>
                <a:ext uri="{FF2B5EF4-FFF2-40B4-BE49-F238E27FC236}">
                  <a16:creationId xmlns:a16="http://schemas.microsoft.com/office/drawing/2014/main" id="{C7CCB5ED-8DC9-4EA1-927F-7019DC2F8D20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8AA9D005-B992-4C7F-BDCB-B015FF5CA964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7" name="テキスト ボックス 1">
              <a:extLst>
                <a:ext uri="{FF2B5EF4-FFF2-40B4-BE49-F238E27FC236}">
                  <a16:creationId xmlns:a16="http://schemas.microsoft.com/office/drawing/2014/main" id="{D891DE08-922F-4854-BCFA-9754F1D53CB8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テキスト ボックス 1">
              <a:extLst>
                <a:ext uri="{FF2B5EF4-FFF2-40B4-BE49-F238E27FC236}">
                  <a16:creationId xmlns:a16="http://schemas.microsoft.com/office/drawing/2014/main" id="{631660B8-C4AB-462C-BA58-0B7186C6CF4C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テキスト ボックス 1">
              <a:extLst>
                <a:ext uri="{FF2B5EF4-FFF2-40B4-BE49-F238E27FC236}">
                  <a16:creationId xmlns:a16="http://schemas.microsoft.com/office/drawing/2014/main" id="{763BC629-37B1-4BC9-A514-F49A7F6D26D6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テキスト ボックス 1">
              <a:extLst>
                <a:ext uri="{FF2B5EF4-FFF2-40B4-BE49-F238E27FC236}">
                  <a16:creationId xmlns:a16="http://schemas.microsoft.com/office/drawing/2014/main" id="{28ED1A6B-D356-476D-8544-C05407C2A4BB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1" name="直線コネクタ 140">
              <a:extLst>
                <a:ext uri="{FF2B5EF4-FFF2-40B4-BE49-F238E27FC236}">
                  <a16:creationId xmlns:a16="http://schemas.microsoft.com/office/drawing/2014/main" id="{0D1E61B4-AA41-48C0-A23A-1CA826D8B869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CF8DFB26-E92C-4106-BC9D-2168EE8675FC}"/>
              </a:ext>
            </a:extLst>
          </p:cNvPr>
          <p:cNvGrpSpPr/>
          <p:nvPr/>
        </p:nvGrpSpPr>
        <p:grpSpPr>
          <a:xfrm>
            <a:off x="2636968" y="7553374"/>
            <a:ext cx="1656128" cy="567978"/>
            <a:chOff x="620744" y="2544775"/>
            <a:chExt cx="1656128" cy="567978"/>
          </a:xfrm>
        </p:grpSpPr>
        <p:sp>
          <p:nvSpPr>
            <p:cNvPr id="143" name="テキスト ボックス 1">
              <a:extLst>
                <a:ext uri="{FF2B5EF4-FFF2-40B4-BE49-F238E27FC236}">
                  <a16:creationId xmlns:a16="http://schemas.microsoft.com/office/drawing/2014/main" id="{B78DEC55-FFE3-46A1-B0E5-3A151C5E9167}"/>
                </a:ext>
              </a:extLst>
            </p:cNvPr>
            <p:cNvSpPr txBox="1"/>
            <p:nvPr/>
          </p:nvSpPr>
          <p:spPr>
            <a:xfrm>
              <a:off x="1260056" y="2688791"/>
              <a:ext cx="1016816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Tomato [</a:t>
              </a:r>
              <a:r>
                <a:rPr lang="en-US" altLang="ja-JP" sz="700" dirty="0" err="1">
                  <a:latin typeface="Arial" pitchFamily="34" charset="0"/>
                  <a:cs typeface="Arial" pitchFamily="34" charset="0"/>
                </a:rPr>
                <a:t>μg</a:t>
              </a:r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/mL]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4AC61284-0CB9-47A0-9EAD-22288AF93D10}"/>
                </a:ext>
              </a:extLst>
            </p:cNvPr>
            <p:cNvCxnSpPr/>
            <p:nvPr/>
          </p:nvCxnSpPr>
          <p:spPr>
            <a:xfrm>
              <a:off x="1088872" y="2864768"/>
              <a:ext cx="97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テキスト ボックス 1">
              <a:extLst>
                <a:ext uri="{FF2B5EF4-FFF2-40B4-BE49-F238E27FC236}">
                  <a16:creationId xmlns:a16="http://schemas.microsoft.com/office/drawing/2014/main" id="{B0BA2FB3-3CAC-4D93-A857-5D188FD779DE}"/>
                </a:ext>
              </a:extLst>
            </p:cNvPr>
            <p:cNvSpPr txBox="1"/>
            <p:nvPr/>
          </p:nvSpPr>
          <p:spPr>
            <a:xfrm>
              <a:off x="1268760" y="2864768"/>
              <a:ext cx="648072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 (+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正方形/長方形 145">
              <a:extLst>
                <a:ext uri="{FF2B5EF4-FFF2-40B4-BE49-F238E27FC236}">
                  <a16:creationId xmlns:a16="http://schemas.microsoft.com/office/drawing/2014/main" id="{C542D38E-B80D-4F4C-8214-5CA0D3755F27}"/>
                </a:ext>
              </a:extLst>
            </p:cNvPr>
            <p:cNvSpPr/>
            <p:nvPr/>
          </p:nvSpPr>
          <p:spPr>
            <a:xfrm>
              <a:off x="773472" y="2584822"/>
              <a:ext cx="121536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7" name="テキスト ボックス 1">
              <a:extLst>
                <a:ext uri="{FF2B5EF4-FFF2-40B4-BE49-F238E27FC236}">
                  <a16:creationId xmlns:a16="http://schemas.microsoft.com/office/drawing/2014/main" id="{EBD64511-1B61-4758-BD17-F4F40AC1551F}"/>
                </a:ext>
              </a:extLst>
            </p:cNvPr>
            <p:cNvSpPr txBox="1"/>
            <p:nvPr/>
          </p:nvSpPr>
          <p:spPr>
            <a:xfrm>
              <a:off x="620744" y="2574000"/>
              <a:ext cx="504000" cy="408408"/>
            </a:xfrm>
            <a:prstGeom prst="rect">
              <a:avLst/>
            </a:prstGeom>
          </p:spPr>
          <p:txBody>
            <a:bodyPr wrap="square" bIns="72000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LPS</a:t>
              </a:r>
            </a:p>
            <a:p>
              <a:pPr algn="ct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(-)</a:t>
              </a:r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テキスト ボックス 1">
              <a:extLst>
                <a:ext uri="{FF2B5EF4-FFF2-40B4-BE49-F238E27FC236}">
                  <a16:creationId xmlns:a16="http://schemas.microsoft.com/office/drawing/2014/main" id="{8E7A470A-C0B7-4B24-B043-B5B66EEA847C}"/>
                </a:ext>
              </a:extLst>
            </p:cNvPr>
            <p:cNvSpPr txBox="1"/>
            <p:nvPr/>
          </p:nvSpPr>
          <p:spPr>
            <a:xfrm>
              <a:off x="111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3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テキスト ボックス 1">
              <a:extLst>
                <a:ext uri="{FF2B5EF4-FFF2-40B4-BE49-F238E27FC236}">
                  <a16:creationId xmlns:a16="http://schemas.microsoft.com/office/drawing/2014/main" id="{9BE38F7E-9411-4E53-9CDB-537CEC837B94}"/>
                </a:ext>
              </a:extLst>
            </p:cNvPr>
            <p:cNvSpPr txBox="1"/>
            <p:nvPr/>
          </p:nvSpPr>
          <p:spPr>
            <a:xfrm>
              <a:off x="1386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テキスト ボックス 1">
              <a:extLst>
                <a:ext uri="{FF2B5EF4-FFF2-40B4-BE49-F238E27FC236}">
                  <a16:creationId xmlns:a16="http://schemas.microsoft.com/office/drawing/2014/main" id="{911E38B8-FE18-4796-827E-AF7D4EF22CE0}"/>
                </a:ext>
              </a:extLst>
            </p:cNvPr>
            <p:cNvSpPr txBox="1"/>
            <p:nvPr/>
          </p:nvSpPr>
          <p:spPr>
            <a:xfrm>
              <a:off x="1692000" y="2544775"/>
              <a:ext cx="416067" cy="2479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altLang="ja-JP" sz="700" b="0" dirty="0">
                  <a:latin typeface="Arial" pitchFamily="34" charset="0"/>
                  <a:cs typeface="Arial" pitchFamily="34" charset="0"/>
                </a:rPr>
                <a:t>120</a:t>
              </a:r>
            </a:p>
            <a:p>
              <a:pPr algn="r"/>
              <a:endParaRPr lang="ja-JP" altLang="en-US" sz="7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E7625930-032D-4F1E-95CF-28B6AADB6A43}"/>
                </a:ext>
              </a:extLst>
            </p:cNvPr>
            <p:cNvCxnSpPr/>
            <p:nvPr/>
          </p:nvCxnSpPr>
          <p:spPr>
            <a:xfrm>
              <a:off x="1304896" y="2720752"/>
              <a:ext cx="72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93540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600" b="1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81</TotalTime>
  <Words>133</Words>
  <Application>Microsoft Office PowerPoint</Application>
  <PresentationFormat>A4 210 x 297 mm</PresentationFormat>
  <Paragraphs>7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高橋　春弥</dc:creator>
  <cp:lastModifiedBy>Shinsuke Mohri</cp:lastModifiedBy>
  <cp:revision>242</cp:revision>
  <cp:lastPrinted>2017-12-21T03:28:14Z</cp:lastPrinted>
  <dcterms:created xsi:type="dcterms:W3CDTF">2016-12-19T09:16:11Z</dcterms:created>
  <dcterms:modified xsi:type="dcterms:W3CDTF">2017-12-25T14:04:45Z</dcterms:modified>
</cp:coreProperties>
</file>